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58" r:id="rId4"/>
    <p:sldId id="259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>
        <p:scale>
          <a:sx n="125" d="100"/>
          <a:sy n="125" d="100"/>
        </p:scale>
        <p:origin x="-4104" y="22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068D6-6F0C-43F8-8B59-FA8BC7F8BA51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E441-CABC-424B-90A2-D0371F2B5C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7130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068D6-6F0C-43F8-8B59-FA8BC7F8BA51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E441-CABC-424B-90A2-D0371F2B5C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4530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068D6-6F0C-43F8-8B59-FA8BC7F8BA51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E441-CABC-424B-90A2-D0371F2B5C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3089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068D6-6F0C-43F8-8B59-FA8BC7F8BA51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E441-CABC-424B-90A2-D0371F2B5C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1690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068D6-6F0C-43F8-8B59-FA8BC7F8BA51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E441-CABC-424B-90A2-D0371F2B5C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5964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068D6-6F0C-43F8-8B59-FA8BC7F8BA51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E441-CABC-424B-90A2-D0371F2B5C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8516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068D6-6F0C-43F8-8B59-FA8BC7F8BA51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E441-CABC-424B-90A2-D0371F2B5C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57538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068D6-6F0C-43F8-8B59-FA8BC7F8BA51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E441-CABC-424B-90A2-D0371F2B5C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2876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068D6-6F0C-43F8-8B59-FA8BC7F8BA51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E441-CABC-424B-90A2-D0371F2B5C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7931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068D6-6F0C-43F8-8B59-FA8BC7F8BA51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E441-CABC-424B-90A2-D0371F2B5C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07245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068D6-6F0C-43F8-8B59-FA8BC7F8BA51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E441-CABC-424B-90A2-D0371F2B5C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71197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C068D6-6F0C-43F8-8B59-FA8BC7F8BA51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8E441-CABC-424B-90A2-D0371F2B5C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8848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1"/>
          <p:cNvSpPr txBox="1">
            <a:spLocks/>
          </p:cNvSpPr>
          <p:nvPr/>
        </p:nvSpPr>
        <p:spPr>
          <a:xfrm>
            <a:off x="3194050" y="227647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err="1" smtClean="0"/>
              <a:t>Figures</a:t>
            </a:r>
            <a:r>
              <a:rPr lang="de-DE" dirty="0" smtClean="0"/>
              <a:t/>
            </a:r>
            <a:br>
              <a:rPr lang="de-DE" dirty="0" smtClean="0"/>
            </a:br>
            <a:r>
              <a:rPr lang="de-DE" dirty="0" smtClean="0"/>
              <a:t>Risser et al 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5912119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483710" y="2165551"/>
            <a:ext cx="4360531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easurement of endogenous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NMP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centrations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O1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wing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B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edium in exponential growth phas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5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) and stationary phase (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.5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 the indicated time points, bacteria were pelleted, extracted and prepared for HPLC-MS/MS based measurement of cyclic nucleotides. Shown are the means of six independent experiments with SD and the corresponding individual data point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*** p&lt;0.001 with Two-Way ANOVA and post hoc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Šídák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orrection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400" dirty="0"/>
          </a:p>
          <a:p>
            <a:endParaRPr lang="en-US" dirty="0"/>
          </a:p>
        </p:txBody>
      </p:sp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1483209"/>
              </p:ext>
            </p:extLst>
          </p:nvPr>
        </p:nvGraphicFramePr>
        <p:xfrm>
          <a:off x="5081364" y="1214841"/>
          <a:ext cx="4934888" cy="3650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5" name="Prism 10" r:id="rId3" imgW="3951769" imgH="2922650" progId="Prism10.Document">
                  <p:embed/>
                </p:oleObj>
              </mc:Choice>
              <mc:Fallback>
                <p:oleObj name="Prism 10" r:id="rId3" imgW="3951769" imgH="2922650" progId="Prism10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81364" y="1214841"/>
                        <a:ext cx="4934888" cy="3650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14058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1094899" y="1897425"/>
            <a:ext cx="4360531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rowth curves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. aeruginos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train PA14 in LB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-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VB medium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-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with add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ative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NMP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100 µM. The control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s medium only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growth i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termin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asuring th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bsorption at </a:t>
            </a:r>
            <a:r>
              <a:rPr lang="en-US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600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m every 10 minutes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acterial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ocul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re set to OD = 0.05 and incubated for 16 h in a 96 well plate.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M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, 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GMP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, f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cCMP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, g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cUMP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, 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were used.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hown are the mean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+- S.E.M. o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ve independent experiments.</a:t>
            </a:r>
          </a:p>
          <a:p>
            <a:endParaRPr lang="en-US" dirty="0"/>
          </a:p>
          <a:p>
            <a:endParaRPr lang="en-US" sz="2400" dirty="0"/>
          </a:p>
          <a:p>
            <a:endParaRPr lang="en-US" dirty="0"/>
          </a:p>
        </p:txBody>
      </p:sp>
      <p:graphicFrame>
        <p:nvGraphicFramePr>
          <p:cNvPr id="4" name="Objekt 3">
            <a:extLst>
              <a:ext uri="{FF2B5EF4-FFF2-40B4-BE49-F238E27FC236}">
                <a16:creationId xmlns:a16="http://schemas.microsoft.com/office/drawing/2014/main" id="{CBABA661-0E57-8019-933F-F0A83FBA62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7033890"/>
              </p:ext>
            </p:extLst>
          </p:nvPr>
        </p:nvGraphicFramePr>
        <p:xfrm>
          <a:off x="6302375" y="658813"/>
          <a:ext cx="4538663" cy="5900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Prism 10" r:id="rId3" imgW="5046222" imgH="6562007" progId="Prism10.Document">
                  <p:embed/>
                </p:oleObj>
              </mc:Choice>
              <mc:Fallback>
                <p:oleObj name="Prism 10" r:id="rId3" imgW="5046222" imgH="6562007" progId="Prism10.Document">
                  <p:embed/>
                  <p:pic>
                    <p:nvPicPr>
                      <p:cNvPr id="4" name="Objekt 3">
                        <a:extLst>
                          <a:ext uri="{FF2B5EF4-FFF2-40B4-BE49-F238E27FC236}">
                            <a16:creationId xmlns:a16="http://schemas.microsoft.com/office/drawing/2014/main" id="{CBABA661-0E57-8019-933F-F0A83FBA62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302375" y="658813"/>
                        <a:ext cx="4538663" cy="5900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65553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27537" y="2498914"/>
            <a:ext cx="436053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rowth behavior of PA14 with the antibacterial drug in combination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NMP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o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NM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AM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 µM. Therefore azithromycin was used in concentrations ranging from 5.34 – 341.8 µM. The absorption was measured after an incubation time of 16 h. For analysis of the mean inhibitory concentration (IC50) a 5-PL-regression was performed. </a:t>
            </a:r>
            <a:b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hown are the means +/- SD of three independent replicates.</a:t>
            </a:r>
          </a:p>
        </p:txBody>
      </p:sp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0505100"/>
              </p:ext>
            </p:extLst>
          </p:nvPr>
        </p:nvGraphicFramePr>
        <p:xfrm>
          <a:off x="4808538" y="1809750"/>
          <a:ext cx="7278687" cy="2947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2" name="Prism 10" r:id="rId3" imgW="6532862" imgH="2645331" progId="Prism10.Document">
                  <p:embed/>
                </p:oleObj>
              </mc:Choice>
              <mc:Fallback>
                <p:oleObj name="Prism 10" r:id="rId3" imgW="6532862" imgH="2645331" progId="Prism10.Document">
                  <p:embed/>
                  <p:pic>
                    <p:nvPicPr>
                      <p:cNvPr id="7" name="Objekt 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808538" y="1809750"/>
                        <a:ext cx="7278687" cy="2947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66531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0</Words>
  <Application>Microsoft Office PowerPoint</Application>
  <PresentationFormat>Breitbild</PresentationFormat>
  <Paragraphs>6</Paragraphs>
  <Slides>4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Symbol</vt:lpstr>
      <vt:lpstr>Office</vt:lpstr>
      <vt:lpstr>GraphPad Prism Project</vt:lpstr>
      <vt:lpstr>PowerPoint-Präsentation</vt:lpstr>
      <vt:lpstr>PowerPoint-Präsentation</vt:lpstr>
      <vt:lpstr>PowerPoint-Präsentation</vt:lpstr>
      <vt:lpstr>PowerPoint-Präsentation</vt:lpstr>
    </vt:vector>
  </TitlesOfParts>
  <Company>MH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chirmer, Bastian Dr.</dc:creator>
  <cp:lastModifiedBy>Schirmer, Bastian Dr.</cp:lastModifiedBy>
  <cp:revision>14</cp:revision>
  <dcterms:created xsi:type="dcterms:W3CDTF">2024-08-06T10:08:54Z</dcterms:created>
  <dcterms:modified xsi:type="dcterms:W3CDTF">2025-09-04T13:53:29Z</dcterms:modified>
</cp:coreProperties>
</file>